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8" d="100"/>
          <a:sy n="78" d="100"/>
        </p:scale>
        <p:origin x="-763" y="-5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7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0230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3741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6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6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6057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4869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90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2608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0035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0307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8026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5167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12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2223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1520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01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401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01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601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11286" y="204088"/>
            <a:ext cx="5998034" cy="4604896"/>
            <a:chOff x="136788" y="2006005"/>
            <a:chExt cx="5998034" cy="4604896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5270" y="4162629"/>
              <a:ext cx="1703664" cy="24482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>
              <a:off x="222056" y="5923930"/>
              <a:ext cx="490797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22056" y="5403697"/>
              <a:ext cx="490797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22056" y="5133332"/>
              <a:ext cx="490797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22056" y="4875817"/>
              <a:ext cx="490797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22056" y="4687746"/>
              <a:ext cx="490797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36788" y="4355471"/>
              <a:ext cx="576065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36788" y="4244276"/>
              <a:ext cx="576065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36788" y="4151966"/>
              <a:ext cx="576065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70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22056" y="4471537"/>
              <a:ext cx="490797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49547" y="3869090"/>
              <a:ext cx="490797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643076" y="5109399"/>
              <a:ext cx="10739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ull Nm-MIP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Straight Arrow Connector 16"/>
            <p:cNvCxnSpPr/>
            <p:nvPr/>
          </p:nvCxnSpPr>
          <p:spPr>
            <a:xfrm flipH="1">
              <a:off x="2467256" y="5285999"/>
              <a:ext cx="216024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2643077" y="5767363"/>
              <a:ext cx="12179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-Nm-MIP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Straight Arrow Connector 18"/>
            <p:cNvCxnSpPr/>
            <p:nvPr/>
          </p:nvCxnSpPr>
          <p:spPr>
            <a:xfrm flipH="1">
              <a:off x="2467256" y="5943962"/>
              <a:ext cx="216024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 rot="16200000">
              <a:off x="797383" y="3566855"/>
              <a:ext cx="9267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C58 WT OM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1194635" y="3522483"/>
              <a:ext cx="10155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C58</a:t>
              </a:r>
              <a:r>
                <a:rPr lang="en-GB" sz="900" b="1" i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mip</a:t>
              </a:r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 </a:t>
              </a:r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OM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1074193" y="2960418"/>
              <a:ext cx="21396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C58</a:t>
              </a:r>
              <a:r>
                <a:rPr lang="en-GB" sz="900" b="1" i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mip</a:t>
              </a:r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::</a:t>
              </a:r>
              <a:r>
                <a:rPr lang="en-GB" sz="900" b="1" i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t-nm-</a:t>
              </a:r>
              <a:r>
                <a:rPr lang="en-GB" sz="900" b="1" i="1" dirty="0" err="1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mip</a:t>
              </a:r>
              <a:r>
                <a:rPr lang="en-GB" sz="900" b="1" i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 </a:t>
              </a:r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OM</a:t>
              </a:r>
              <a:endParaRPr lang="en-GB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89432" y="2827858"/>
              <a:ext cx="4320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48571" y="4125239"/>
              <a:ext cx="1586251" cy="23666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4" name="TextBox 23"/>
            <p:cNvSpPr txBox="1"/>
            <p:nvPr/>
          </p:nvSpPr>
          <p:spPr>
            <a:xfrm>
              <a:off x="4074847" y="5795400"/>
              <a:ext cx="490797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074847" y="5284692"/>
              <a:ext cx="490797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074847" y="5023851"/>
              <a:ext cx="490797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074847" y="4747287"/>
              <a:ext cx="490797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074847" y="4568742"/>
              <a:ext cx="490797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989579" y="4236464"/>
              <a:ext cx="576065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989579" y="4115746"/>
              <a:ext cx="576065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989579" y="4032960"/>
              <a:ext cx="576065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170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074847" y="4362057"/>
              <a:ext cx="490797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102338" y="3749458"/>
              <a:ext cx="490797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 rot="16200000">
              <a:off x="4631124" y="3566855"/>
              <a:ext cx="9267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C58 WT OM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 rot="16200000">
              <a:off x="5009325" y="3522483"/>
              <a:ext cx="10155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C58</a:t>
              </a:r>
              <a:r>
                <a:rPr lang="en-GB" sz="900" b="1" i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mip</a:t>
              </a:r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 </a:t>
              </a:r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OM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 rot="16200000">
              <a:off x="4905837" y="2996421"/>
              <a:ext cx="206765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C58</a:t>
              </a:r>
              <a:r>
                <a:rPr lang="en-GB" sz="900" b="1" i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mip</a:t>
              </a:r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::</a:t>
              </a:r>
              <a:r>
                <a:rPr lang="en-GB" sz="900" b="1" i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t-nm-</a:t>
              </a:r>
              <a:r>
                <a:rPr lang="en-GB" sz="900" b="1" i="1" dirty="0" err="1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mip</a:t>
              </a:r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 OM</a:t>
              </a:r>
              <a:endParaRPr lang="en-GB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074847" y="6170299"/>
              <a:ext cx="490797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023115" y="2827858"/>
              <a:ext cx="4320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476672" y="4895508"/>
            <a:ext cx="5882112" cy="15696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upplementary Fig 5. Analysis of MC58 wild-type (WT), MC58</a:t>
            </a:r>
            <a:r>
              <a:rPr kumimoji="0" lang="en-GB" altLang="en-US" sz="12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</a:t>
            </a:r>
            <a:r>
              <a:rPr kumimoji="0" lang="en-GB" altLang="en-US" sz="12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mip</a:t>
            </a:r>
            <a:r>
              <a:rPr kumimoji="0" lang="en-GB" alt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 and MC58</a:t>
            </a:r>
            <a:r>
              <a:rPr kumimoji="0" lang="en-GB" altLang="en-US" sz="12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</a:t>
            </a:r>
            <a:r>
              <a:rPr kumimoji="0" lang="en-GB" altLang="en-US" sz="12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mip::t-nm-</a:t>
            </a:r>
            <a:r>
              <a:rPr kumimoji="0" lang="en-GB" altLang="en-US" sz="12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mip</a:t>
            </a:r>
            <a:r>
              <a:rPr kumimoji="0" lang="en-GB" alt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 OM preparations. </a:t>
            </a:r>
            <a:r>
              <a:rPr kumimoji="0" lang="en-GB" altLang="en-US" sz="12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A) OM preparations (20 </a:t>
            </a:r>
            <a:r>
              <a:rPr kumimoji="0" lang="en-GB" altLang="en-US" sz="12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/>
                <a:ea typeface="SimSun" pitchFamily="2" charset="-122"/>
                <a:cs typeface="Times New Roman" pitchFamily="18" charset="0"/>
                <a:sym typeface="Symbol" pitchFamily="18" charset="2"/>
              </a:rPr>
              <a:t>µ</a:t>
            </a:r>
            <a:r>
              <a:rPr kumimoji="0" lang="en-GB" altLang="en-US" sz="12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g) of MC58 WT, </a:t>
            </a:r>
            <a:r>
              <a:rPr kumimoji="0" lang="en-GB" altLang="en-US" sz="12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mip</a:t>
            </a:r>
            <a:r>
              <a:rPr kumimoji="0" lang="en-GB" altLang="en-US" sz="12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 knock-out and complemented with </a:t>
            </a:r>
            <a:r>
              <a:rPr kumimoji="0" lang="en-GB" altLang="en-US" sz="120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rT</a:t>
            </a:r>
            <a:r>
              <a:rPr kumimoji="0" lang="en-GB" altLang="en-US" sz="12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-Nm-MIP strains were reacted with polyclonal rabbit sera (1/400 dilution) raised against full length </a:t>
            </a:r>
            <a:r>
              <a:rPr kumimoji="0" lang="en-GB" altLang="en-US" sz="120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rNm</a:t>
            </a:r>
            <a:r>
              <a:rPr kumimoji="0" lang="en-GB" altLang="en-US" sz="12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-MIP Type I (M2) [17] in Western immunoblotting. Full length WT and truncated Nm-MIP proteins were recognised as a single band of Mr ~29 </a:t>
            </a:r>
            <a:r>
              <a:rPr kumimoji="0" lang="en-GB" altLang="en-US" sz="120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kDa</a:t>
            </a:r>
            <a:r>
              <a:rPr kumimoji="0" lang="en-GB" altLang="en-US" sz="12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 and ~14 </a:t>
            </a:r>
            <a:r>
              <a:rPr kumimoji="0" lang="en-GB" altLang="en-US" sz="120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kDa</a:t>
            </a:r>
            <a:r>
              <a:rPr kumimoji="0" lang="en-GB" altLang="en-US" sz="12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, respectively (identified by the arrow). MIP was not detected in the MC58</a:t>
            </a:r>
            <a:r>
              <a:rPr kumimoji="0" lang="en-GB" altLang="en-US" sz="12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</a:t>
            </a:r>
            <a:r>
              <a:rPr kumimoji="0" lang="en-GB" altLang="en-US" sz="12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mip</a:t>
            </a:r>
            <a:r>
              <a:rPr kumimoji="0" lang="en-GB" altLang="en-US" sz="12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 </a:t>
            </a:r>
            <a:r>
              <a:rPr kumimoji="0" lang="en-GB" altLang="en-US" sz="12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OM preparation. B) SDS-PAGE of 20 </a:t>
            </a:r>
            <a:r>
              <a:rPr kumimoji="0" lang="en-GB" altLang="en-US" sz="12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/>
                <a:ea typeface="SimSun" pitchFamily="2" charset="-122"/>
                <a:cs typeface="Times New Roman" pitchFamily="18" charset="0"/>
                <a:sym typeface="Symbol" pitchFamily="18" charset="2"/>
              </a:rPr>
              <a:t>µ</a:t>
            </a:r>
            <a:r>
              <a:rPr kumimoji="0" lang="en-GB" altLang="en-US" sz="120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  <a:sym typeface="Symbol" pitchFamily="18" charset="2"/>
              </a:rPr>
              <a:t>g of each OM preparation.</a:t>
            </a:r>
          </a:p>
        </p:txBody>
      </p:sp>
    </p:spTree>
    <p:extLst>
      <p:ext uri="{BB962C8B-B14F-4D97-AF65-F5344CB8AC3E}">
        <p14:creationId xmlns:p14="http://schemas.microsoft.com/office/powerpoint/2010/main" val="2116183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67</TotalTime>
  <Words>174</Words>
  <Application>Microsoft Office PowerPoint</Application>
  <PresentationFormat>A4 Paper (210x297 mm)</PresentationFormat>
  <Paragraphs>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Southampt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mbert M.V.</dc:creator>
  <cp:lastModifiedBy>Christodoulides M.</cp:lastModifiedBy>
  <cp:revision>124</cp:revision>
  <dcterms:created xsi:type="dcterms:W3CDTF">2017-05-24T10:25:23Z</dcterms:created>
  <dcterms:modified xsi:type="dcterms:W3CDTF">2018-02-16T12:17:04Z</dcterms:modified>
</cp:coreProperties>
</file>